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70" r:id="rId2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192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1451"/>
    <p:restoredTop sz="94567" autoAdjust="0"/>
  </p:normalViewPr>
  <p:slideViewPr>
    <p:cSldViewPr snapToGrid="0" snapToObjects="1">
      <p:cViewPr>
        <p:scale>
          <a:sx n="227" d="100"/>
          <a:sy n="227" d="100"/>
        </p:scale>
        <p:origin x="-1000" y="168"/>
      </p:cViewPr>
      <p:guideLst>
        <p:guide orient="horz" pos="2880"/>
        <p:guide pos="1927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nsen:Desktop:&#30740;&#31350;:&#20491;&#20154;&#12501;&#12457;&#12523;&#12480;%20(Personal%20Folder):&#31070;&#23665;:&#35542;&#25991;:ZIKA-EAE:20250501%20International%20immunology%20&#25237;&#31295;&#35542;&#25991;%20&#12522;&#12496;&#12452;&#12473;:20251008%20polyIC%20EAE%20%20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kansen:Desktop:&#30740;&#31350;:&#20491;&#20154;&#12501;&#12457;&#12523;&#12480;%20(Personal%20Folder):&#31070;&#23665;:&#35542;&#25991;:ZIKA-EAE:20250501%20International%20immunology%20&#25237;&#31295;&#35542;&#25991;%20&#12522;&#12496;&#12452;&#12473;:20251008%20polyIC%20EAE%20%20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0803803587051618"/>
          <c:y val="0.0601851851851852"/>
          <c:w val="0.889448381452318"/>
          <c:h val="0.756798993875765"/>
        </c:manualLayout>
      </c:layout>
      <c:lineChart>
        <c:grouping val="standard"/>
        <c:varyColors val="0"/>
        <c:ser>
          <c:idx val="0"/>
          <c:order val="0"/>
          <c:tx>
            <c:strRef>
              <c:f>Sheet1!$A$51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54:$W$54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333333333333333</c:v>
                  </c:pt>
                  <c:pt idx="11">
                    <c:v>0.5</c:v>
                  </c:pt>
                  <c:pt idx="12">
                    <c:v>0.52704627669473</c:v>
                  </c:pt>
                  <c:pt idx="13">
                    <c:v>0.5</c:v>
                  </c:pt>
                  <c:pt idx="14">
                    <c:v>0.5</c:v>
                  </c:pt>
                  <c:pt idx="15">
                    <c:v>0.52704627669473</c:v>
                  </c:pt>
                  <c:pt idx="16">
                    <c:v>0.707106781186548</c:v>
                  </c:pt>
                  <c:pt idx="17">
                    <c:v>0.440958551844099</c:v>
                  </c:pt>
                  <c:pt idx="18">
                    <c:v>0.440958551844099</c:v>
                  </c:pt>
                  <c:pt idx="19">
                    <c:v>0.5</c:v>
                  </c:pt>
                  <c:pt idx="20">
                    <c:v>0.600925212577331</c:v>
                  </c:pt>
                  <c:pt idx="21">
                    <c:v>0.5270462766947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>
                <a:solidFill>
                  <a:schemeClr val="bg1">
                    <a:lumMod val="50000"/>
                  </a:schemeClr>
                </a:solidFill>
              </a:ln>
            </c:spPr>
          </c:errBars>
          <c:cat>
            <c:strRef>
              <c:f>Sheet1!$B$37:$W$37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51:$W$51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111111111111111</c:v>
                </c:pt>
                <c:pt idx="11">
                  <c:v>0.666666666666667</c:v>
                </c:pt>
                <c:pt idx="12">
                  <c:v>1.444444444444444</c:v>
                </c:pt>
                <c:pt idx="13">
                  <c:v>1.666666666666667</c:v>
                </c:pt>
                <c:pt idx="14">
                  <c:v>2.333333333333333</c:v>
                </c:pt>
                <c:pt idx="15">
                  <c:v>2.444444444444445</c:v>
                </c:pt>
                <c:pt idx="16">
                  <c:v>2.666666666666666</c:v>
                </c:pt>
                <c:pt idx="17">
                  <c:v>2.777777777777778</c:v>
                </c:pt>
                <c:pt idx="18">
                  <c:v>2.777777777777778</c:v>
                </c:pt>
                <c:pt idx="19">
                  <c:v>3.0</c:v>
                </c:pt>
                <c:pt idx="20">
                  <c:v>2.888888888888888</c:v>
                </c:pt>
                <c:pt idx="21">
                  <c:v>2.555555555555555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52</c:f>
              <c:strCache>
                <c:ptCount val="1"/>
                <c:pt idx="0">
                  <c:v>polyIC</c:v>
                </c:pt>
              </c:strCache>
            </c:strRef>
          </c:tx>
          <c:spPr>
            <a:ln w="15875">
              <a:solidFill>
                <a:srgbClr val="0000FF"/>
              </a:solidFill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heet1!$B$55:$W$55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0.0</c:v>
                  </c:pt>
                  <c:pt idx="2">
                    <c:v>0.0</c:v>
                  </c:pt>
                  <c:pt idx="3">
                    <c:v>0.0</c:v>
                  </c:pt>
                  <c:pt idx="4">
                    <c:v>0.0</c:v>
                  </c:pt>
                  <c:pt idx="5">
                    <c:v>0.0</c:v>
                  </c:pt>
                  <c:pt idx="6">
                    <c:v>0.0</c:v>
                  </c:pt>
                  <c:pt idx="7">
                    <c:v>0.0</c:v>
                  </c:pt>
                  <c:pt idx="8">
                    <c:v>0.0</c:v>
                  </c:pt>
                  <c:pt idx="9">
                    <c:v>0.0</c:v>
                  </c:pt>
                  <c:pt idx="10">
                    <c:v>0.577350269189626</c:v>
                  </c:pt>
                  <c:pt idx="11">
                    <c:v>0.577350269189626</c:v>
                  </c:pt>
                  <c:pt idx="12">
                    <c:v>1.154700538379252</c:v>
                  </c:pt>
                  <c:pt idx="13">
                    <c:v>0.577350269189626</c:v>
                  </c:pt>
                  <c:pt idx="14">
                    <c:v>0.577350269189626</c:v>
                  </c:pt>
                  <c:pt idx="15">
                    <c:v>0.577350269189626</c:v>
                  </c:pt>
                  <c:pt idx="16">
                    <c:v>0.577350269189626</c:v>
                  </c:pt>
                  <c:pt idx="17">
                    <c:v>1.0</c:v>
                  </c:pt>
                  <c:pt idx="18">
                    <c:v>1.0</c:v>
                  </c:pt>
                  <c:pt idx="19">
                    <c:v>1.0</c:v>
                  </c:pt>
                  <c:pt idx="20">
                    <c:v>0.577350269189626</c:v>
                  </c:pt>
                  <c:pt idx="21">
                    <c:v>0.577350269189626</c:v>
                  </c:pt>
                </c:numCache>
              </c:numRef>
            </c:minus>
            <c:spPr>
              <a:ln>
                <a:solidFill>
                  <a:schemeClr val="bg1">
                    <a:lumMod val="50000"/>
                  </a:schemeClr>
                </a:solidFill>
              </a:ln>
            </c:spPr>
          </c:errBars>
          <c:cat>
            <c:strRef>
              <c:f>Sheet1!$B$37:$W$37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52:$W$52</c:f>
              <c:numCache>
                <c:formatCode>General</c:formatCode>
                <c:ptCount val="22"/>
                <c:pt idx="0">
                  <c:v>0.0</c:v>
                </c:pt>
                <c:pt idx="1">
                  <c:v>0.0</c:v>
                </c:pt>
                <c:pt idx="2">
                  <c:v>0.0</c:v>
                </c:pt>
                <c:pt idx="3">
                  <c:v>0.0</c:v>
                </c:pt>
                <c:pt idx="4">
                  <c:v>0.0</c:v>
                </c:pt>
                <c:pt idx="5">
                  <c:v>0.0</c:v>
                </c:pt>
                <c:pt idx="6">
                  <c:v>0.0</c:v>
                </c:pt>
                <c:pt idx="7">
                  <c:v>0.0</c:v>
                </c:pt>
                <c:pt idx="8">
                  <c:v>0.0</c:v>
                </c:pt>
                <c:pt idx="9">
                  <c:v>0.0</c:v>
                </c:pt>
                <c:pt idx="10">
                  <c:v>0.333333333333333</c:v>
                </c:pt>
                <c:pt idx="11">
                  <c:v>0.333333333333333</c:v>
                </c:pt>
                <c:pt idx="12">
                  <c:v>0.666666666666667</c:v>
                </c:pt>
                <c:pt idx="13">
                  <c:v>1.333333333333333</c:v>
                </c:pt>
                <c:pt idx="14">
                  <c:v>2.333333333333333</c:v>
                </c:pt>
                <c:pt idx="15">
                  <c:v>2.333333333333333</c:v>
                </c:pt>
                <c:pt idx="16">
                  <c:v>2.666666666666666</c:v>
                </c:pt>
                <c:pt idx="17">
                  <c:v>3.0</c:v>
                </c:pt>
                <c:pt idx="18">
                  <c:v>3.0</c:v>
                </c:pt>
                <c:pt idx="19">
                  <c:v>3.0</c:v>
                </c:pt>
                <c:pt idx="20">
                  <c:v>2.666666666666666</c:v>
                </c:pt>
                <c:pt idx="21">
                  <c:v>2.666666666666666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434289168"/>
        <c:axId val="-1657872224"/>
      </c:lineChart>
      <c:catAx>
        <c:axId val="-143428916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1657872224"/>
        <c:crosses val="autoZero"/>
        <c:auto val="1"/>
        <c:lblAlgn val="ctr"/>
        <c:lblOffset val="100"/>
        <c:noMultiLvlLbl val="0"/>
      </c:catAx>
      <c:valAx>
        <c:axId val="-1657872224"/>
        <c:scaling>
          <c:orientation val="minMax"/>
          <c:max val="5.0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200"/>
            </a:pPr>
            <a:endParaRPr lang="ja-JP"/>
          </a:p>
        </c:txPr>
        <c:crossAx val="-143428916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Sheet1!$A$30</c:f>
              <c:strCache>
                <c:ptCount val="1"/>
                <c:pt idx="0">
                  <c:v>(-)</c:v>
                </c:pt>
              </c:strCache>
            </c:strRef>
          </c:tx>
          <c:spPr>
            <a:ln w="15875">
              <a:solidFill>
                <a:schemeClr val="tx1"/>
              </a:solidFill>
            </a:ln>
            <a:effectLst/>
          </c:spPr>
          <c:marker>
            <c:symbol val="triangl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1!$B$33:$W$33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550029902114202</c:v>
                  </c:pt>
                  <c:pt idx="2">
                    <c:v>1.60158996616929</c:v>
                  </c:pt>
                  <c:pt idx="3">
                    <c:v>1.569091382741787</c:v>
                  </c:pt>
                  <c:pt idx="4">
                    <c:v>0.722512541455288</c:v>
                  </c:pt>
                  <c:pt idx="5">
                    <c:v>1.037518801682064</c:v>
                  </c:pt>
                  <c:pt idx="6">
                    <c:v>1.11404706071727</c:v>
                  </c:pt>
                  <c:pt idx="7">
                    <c:v>2.742277257240216</c:v>
                  </c:pt>
                  <c:pt idx="8">
                    <c:v>2.235542021472953</c:v>
                  </c:pt>
                  <c:pt idx="9">
                    <c:v>1.802865537726723</c:v>
                  </c:pt>
                  <c:pt idx="10">
                    <c:v>2.347319336430437</c:v>
                  </c:pt>
                  <c:pt idx="11">
                    <c:v>1.965398768736173</c:v>
                  </c:pt>
                  <c:pt idx="12">
                    <c:v>2.755772020063292</c:v>
                  </c:pt>
                  <c:pt idx="13">
                    <c:v>3.225349187178292</c:v>
                  </c:pt>
                  <c:pt idx="14">
                    <c:v>3.809176717215455</c:v>
                  </c:pt>
                  <c:pt idx="15">
                    <c:v>3.808159713273984</c:v>
                  </c:pt>
                  <c:pt idx="16">
                    <c:v>3.25382355593809</c:v>
                  </c:pt>
                  <c:pt idx="17">
                    <c:v>2.874383785621385</c:v>
                  </c:pt>
                  <c:pt idx="18">
                    <c:v>3.556360168732771</c:v>
                  </c:pt>
                  <c:pt idx="19">
                    <c:v>2.420820965907331</c:v>
                  </c:pt>
                  <c:pt idx="20">
                    <c:v>1.73608632563616</c:v>
                  </c:pt>
                  <c:pt idx="21">
                    <c:v>2.95076505637057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.0</c:v>
                </c:pt>
              </c:numLit>
            </c:minus>
            <c:spPr>
              <a:ln>
                <a:solidFill>
                  <a:schemeClr val="bg1">
                    <a:lumMod val="50000"/>
                  </a:schemeClr>
                </a:solidFill>
              </a:ln>
            </c:spPr>
          </c:errBars>
          <c:cat>
            <c:strRef>
              <c:f>Sheet1!$B$16:$W$16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30:$W$30</c:f>
              <c:numCache>
                <c:formatCode>General</c:formatCode>
                <c:ptCount val="22"/>
                <c:pt idx="0">
                  <c:v>100.0</c:v>
                </c:pt>
                <c:pt idx="1">
                  <c:v>101.3578587739629</c:v>
                </c:pt>
                <c:pt idx="2">
                  <c:v>101.4536788080665</c:v>
                </c:pt>
                <c:pt idx="3">
                  <c:v>102.1998482027412</c:v>
                </c:pt>
                <c:pt idx="4">
                  <c:v>102.6954626438715</c:v>
                </c:pt>
                <c:pt idx="5">
                  <c:v>103.0627523081718</c:v>
                </c:pt>
                <c:pt idx="6">
                  <c:v>103.6344524710002</c:v>
                </c:pt>
                <c:pt idx="7">
                  <c:v>103.5258579535339</c:v>
                </c:pt>
                <c:pt idx="8">
                  <c:v>104.6730665052748</c:v>
                </c:pt>
                <c:pt idx="9">
                  <c:v>105.8930689075337</c:v>
                </c:pt>
                <c:pt idx="10">
                  <c:v>105.017236028808</c:v>
                </c:pt>
                <c:pt idx="11">
                  <c:v>103.7826567913357</c:v>
                </c:pt>
                <c:pt idx="12">
                  <c:v>101.8226427035492</c:v>
                </c:pt>
                <c:pt idx="13">
                  <c:v>99.7764469485781</c:v>
                </c:pt>
                <c:pt idx="14">
                  <c:v>95.33028464706383</c:v>
                </c:pt>
                <c:pt idx="15">
                  <c:v>92.57794235518438</c:v>
                </c:pt>
                <c:pt idx="16">
                  <c:v>90.67889974736647</c:v>
                </c:pt>
                <c:pt idx="17">
                  <c:v>92.22348523746786</c:v>
                </c:pt>
                <c:pt idx="18">
                  <c:v>94.4399442803493</c:v>
                </c:pt>
                <c:pt idx="19">
                  <c:v>96.14202640866095</c:v>
                </c:pt>
                <c:pt idx="20">
                  <c:v>97.85451007678586</c:v>
                </c:pt>
                <c:pt idx="21">
                  <c:v>99.4747802867378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1!$A$31</c:f>
              <c:strCache>
                <c:ptCount val="1"/>
                <c:pt idx="0">
                  <c:v>polyIC</c:v>
                </c:pt>
              </c:strCache>
            </c:strRef>
          </c:tx>
          <c:spPr>
            <a:ln w="15875">
              <a:solidFill>
                <a:srgbClr val="0000FF"/>
              </a:solidFill>
            </a:ln>
            <a:effectLst/>
          </c:spPr>
          <c:marker>
            <c:symbol val="circle"/>
            <c:size val="4"/>
            <c:spPr>
              <a:solidFill>
                <a:srgbClr val="0000FF"/>
              </a:solidFill>
              <a:ln>
                <a:solidFill>
                  <a:srgbClr val="0000FF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plus>
              <c:numLit>
                <c:formatCode>General</c:formatCode>
                <c:ptCount val="1"/>
                <c:pt idx="0">
                  <c:v>1.0</c:v>
                </c:pt>
              </c:numLit>
            </c:plus>
            <c:minus>
              <c:numRef>
                <c:f>Sheet1!$B$34:$W$34</c:f>
                <c:numCache>
                  <c:formatCode>General</c:formatCode>
                  <c:ptCount val="22"/>
                  <c:pt idx="0">
                    <c:v>0.0</c:v>
                  </c:pt>
                  <c:pt idx="1">
                    <c:v>1.175019821124664</c:v>
                  </c:pt>
                  <c:pt idx="2">
                    <c:v>3.510357365910203</c:v>
                  </c:pt>
                  <c:pt idx="3">
                    <c:v>3.242618426702834</c:v>
                  </c:pt>
                  <c:pt idx="4">
                    <c:v>3.287067251784852</c:v>
                  </c:pt>
                  <c:pt idx="5">
                    <c:v>2.92578128267623</c:v>
                  </c:pt>
                  <c:pt idx="6">
                    <c:v>2.992227893015858</c:v>
                  </c:pt>
                  <c:pt idx="7">
                    <c:v>2.376406282567981</c:v>
                  </c:pt>
                  <c:pt idx="8">
                    <c:v>2.360480056295741</c:v>
                  </c:pt>
                  <c:pt idx="9">
                    <c:v>1.032548653287061</c:v>
                  </c:pt>
                  <c:pt idx="10">
                    <c:v>0.802244270006474</c:v>
                  </c:pt>
                  <c:pt idx="11">
                    <c:v>1.372636691646718</c:v>
                  </c:pt>
                  <c:pt idx="12">
                    <c:v>0.935722136680967</c:v>
                  </c:pt>
                  <c:pt idx="13">
                    <c:v>0.900563784130845</c:v>
                  </c:pt>
                  <c:pt idx="14">
                    <c:v>2.881203224000514</c:v>
                  </c:pt>
                  <c:pt idx="15">
                    <c:v>5.655083274006554</c:v>
                  </c:pt>
                  <c:pt idx="16">
                    <c:v>6.219929842296874</c:v>
                  </c:pt>
                  <c:pt idx="17">
                    <c:v>5.78729366801637</c:v>
                  </c:pt>
                  <c:pt idx="18">
                    <c:v>5.584008713694657</c:v>
                  </c:pt>
                  <c:pt idx="19">
                    <c:v>6.05169324196283</c:v>
                  </c:pt>
                  <c:pt idx="20">
                    <c:v>5.629063731482084</c:v>
                  </c:pt>
                  <c:pt idx="21">
                    <c:v>5.00624870515838</c:v>
                  </c:pt>
                </c:numCache>
              </c:numRef>
            </c:minus>
            <c:spPr>
              <a:ln>
                <a:solidFill>
                  <a:schemeClr val="bg1">
                    <a:lumMod val="50000"/>
                  </a:schemeClr>
                </a:solidFill>
              </a:ln>
            </c:spPr>
          </c:errBars>
          <c:cat>
            <c:strRef>
              <c:f>Sheet1!$B$16:$W$16</c:f>
              <c:strCache>
                <c:ptCount val="22"/>
                <c:pt idx="0">
                  <c:v>day0</c:v>
                </c:pt>
                <c:pt idx="1">
                  <c:v>day1</c:v>
                </c:pt>
                <c:pt idx="2">
                  <c:v>day2</c:v>
                </c:pt>
                <c:pt idx="3">
                  <c:v>day3</c:v>
                </c:pt>
                <c:pt idx="4">
                  <c:v>day4</c:v>
                </c:pt>
                <c:pt idx="5">
                  <c:v>day5</c:v>
                </c:pt>
                <c:pt idx="6">
                  <c:v>day6</c:v>
                </c:pt>
                <c:pt idx="7">
                  <c:v>day7</c:v>
                </c:pt>
                <c:pt idx="8">
                  <c:v>day8</c:v>
                </c:pt>
                <c:pt idx="9">
                  <c:v>day9</c:v>
                </c:pt>
                <c:pt idx="10">
                  <c:v>day10</c:v>
                </c:pt>
                <c:pt idx="11">
                  <c:v>day11</c:v>
                </c:pt>
                <c:pt idx="12">
                  <c:v>day12</c:v>
                </c:pt>
                <c:pt idx="13">
                  <c:v>day13</c:v>
                </c:pt>
                <c:pt idx="14">
                  <c:v>day14</c:v>
                </c:pt>
                <c:pt idx="15">
                  <c:v>day15</c:v>
                </c:pt>
                <c:pt idx="16">
                  <c:v>day16</c:v>
                </c:pt>
                <c:pt idx="17">
                  <c:v>day17</c:v>
                </c:pt>
                <c:pt idx="18">
                  <c:v>day18</c:v>
                </c:pt>
                <c:pt idx="19">
                  <c:v>day19</c:v>
                </c:pt>
                <c:pt idx="20">
                  <c:v>day20</c:v>
                </c:pt>
                <c:pt idx="21">
                  <c:v>day21</c:v>
                </c:pt>
              </c:strCache>
            </c:strRef>
          </c:cat>
          <c:val>
            <c:numRef>
              <c:f>Sheet1!$B$31:$W$31</c:f>
              <c:numCache>
                <c:formatCode>General</c:formatCode>
                <c:ptCount val="22"/>
                <c:pt idx="0">
                  <c:v>100.0</c:v>
                </c:pt>
                <c:pt idx="1">
                  <c:v>100.911711961229</c:v>
                </c:pt>
                <c:pt idx="2">
                  <c:v>102.61408062315</c:v>
                </c:pt>
                <c:pt idx="3">
                  <c:v>102.6759425218855</c:v>
                </c:pt>
                <c:pt idx="4">
                  <c:v>102.3349278086375</c:v>
                </c:pt>
                <c:pt idx="5">
                  <c:v>102.6702384242418</c:v>
                </c:pt>
                <c:pt idx="6">
                  <c:v>103.3710797124153</c:v>
                </c:pt>
                <c:pt idx="7">
                  <c:v>103.5204162573111</c:v>
                </c:pt>
                <c:pt idx="8">
                  <c:v>104.0141384910697</c:v>
                </c:pt>
                <c:pt idx="9">
                  <c:v>104.2850825683219</c:v>
                </c:pt>
                <c:pt idx="10">
                  <c:v>103.8648141856049</c:v>
                </c:pt>
                <c:pt idx="11">
                  <c:v>102.8639219008692</c:v>
                </c:pt>
                <c:pt idx="12">
                  <c:v>101.5327257237559</c:v>
                </c:pt>
                <c:pt idx="13">
                  <c:v>101.3233778895245</c:v>
                </c:pt>
                <c:pt idx="14">
                  <c:v>98.33750943281647</c:v>
                </c:pt>
                <c:pt idx="15">
                  <c:v>92.88107960518841</c:v>
                </c:pt>
                <c:pt idx="16">
                  <c:v>90.93860250280311</c:v>
                </c:pt>
                <c:pt idx="17">
                  <c:v>91.08300357349728</c:v>
                </c:pt>
                <c:pt idx="18">
                  <c:v>92.3545747606076</c:v>
                </c:pt>
                <c:pt idx="19">
                  <c:v>94.9490049722579</c:v>
                </c:pt>
                <c:pt idx="20">
                  <c:v>96.8591646983407</c:v>
                </c:pt>
                <c:pt idx="21">
                  <c:v>98.1289675688329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1515642112"/>
        <c:axId val="-1515640336"/>
      </c:lineChart>
      <c:catAx>
        <c:axId val="-151564211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crossAx val="-1515640336"/>
        <c:crosses val="autoZero"/>
        <c:auto val="1"/>
        <c:lblAlgn val="ctr"/>
        <c:lblOffset val="100"/>
        <c:noMultiLvlLbl val="0"/>
      </c:catAx>
      <c:valAx>
        <c:axId val="-1515640336"/>
        <c:scaling>
          <c:orientation val="minMax"/>
          <c:max val="120.0"/>
          <c:min val="85.0"/>
        </c:scaling>
        <c:delete val="0"/>
        <c:axPos val="l"/>
        <c:numFmt formatCode="General" sourceLinked="1"/>
        <c:majorTickMark val="out"/>
        <c:minorTickMark val="none"/>
        <c:tickLblPos val="nextTo"/>
        <c:crossAx val="-15156421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B1B4E21-F6CD-9F42-BC12-6716A2311E9A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0999E1D-F594-7D47-B0D0-FBEEAB6878A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287868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8732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84250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08964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8162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469752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44987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45977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349002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217998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1040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48870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2BD6FF-7F35-5C4C-9264-18248EDF21BB}" type="datetimeFigureOut">
              <a:rPr kumimoji="1" lang="ja-JP" altLang="en-US" smtClean="0"/>
              <a:t>2025/11/4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FA3FD2-60D6-7E4D-B502-66D9A2A4E18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6082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chart" Target="../charts/chart1.xml"/><Relationship Id="rId3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45"/>
          <p:cNvSpPr txBox="1">
            <a:spLocks noChangeArrowheads="1"/>
          </p:cNvSpPr>
          <p:nvPr/>
        </p:nvSpPr>
        <p:spPr bwMode="auto">
          <a:xfrm>
            <a:off x="1326163" y="32098"/>
            <a:ext cx="5671708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sz="1800" dirty="0">
                <a:latin typeface="Helvetica"/>
                <a:cs typeface="Helvetica"/>
              </a:rPr>
              <a:t> </a:t>
            </a:r>
            <a:r>
              <a:rPr lang="en-US" altLang="ja-JP">
                <a:latin typeface="Helvetica"/>
                <a:cs typeface="Helvetica"/>
              </a:rPr>
              <a:t>Supplementary </a:t>
            </a:r>
            <a:r>
              <a:rPr lang="en-US" altLang="ja-JP" smtClean="0">
                <a:latin typeface="Helvetica"/>
                <a:cs typeface="Helvetica"/>
              </a:rPr>
              <a:t>Fig.S6_Kamiyama </a:t>
            </a:r>
            <a:r>
              <a:rPr lang="en-US" altLang="ja-JP" dirty="0">
                <a:latin typeface="Helvetica"/>
                <a:cs typeface="Helvetica"/>
              </a:rPr>
              <a:t>et al.</a:t>
            </a:r>
            <a:endParaRPr lang="ja-JP" altLang="en-US" dirty="0">
              <a:latin typeface="Helvetica"/>
              <a:cs typeface="Helvetica"/>
            </a:endParaRPr>
          </a:p>
        </p:txBody>
      </p:sp>
      <p:sp>
        <p:nvSpPr>
          <p:cNvPr id="18" name="正方形/長方形 17"/>
          <p:cNvSpPr/>
          <p:nvPr/>
        </p:nvSpPr>
        <p:spPr>
          <a:xfrm rot="16200000">
            <a:off x="-658011" y="1798382"/>
            <a:ext cx="2031002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27" name="テキスト ボックス 44"/>
          <p:cNvSpPr txBox="1">
            <a:spLocks noChangeArrowheads="1"/>
          </p:cNvSpPr>
          <p:nvPr/>
        </p:nvSpPr>
        <p:spPr bwMode="auto">
          <a:xfrm>
            <a:off x="58609" y="686669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 charset="0"/>
                <a:cs typeface="Helvetica" charset="0"/>
              </a:rPr>
              <a:t>A</a:t>
            </a:r>
            <a:endParaRPr lang="ja-JP" altLang="en-US" dirty="0">
              <a:latin typeface="Helvetica" charset="0"/>
              <a:cs typeface="Helvetica" charset="0"/>
            </a:endParaRPr>
          </a:p>
        </p:txBody>
      </p:sp>
      <p:sp>
        <p:nvSpPr>
          <p:cNvPr id="28" name="テキスト ボックス 44"/>
          <p:cNvSpPr txBox="1">
            <a:spLocks noChangeArrowheads="1"/>
          </p:cNvSpPr>
          <p:nvPr/>
        </p:nvSpPr>
        <p:spPr bwMode="auto">
          <a:xfrm>
            <a:off x="3486101" y="686669"/>
            <a:ext cx="389951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 xmlns="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r>
              <a:rPr lang="en-US" altLang="ja-JP" dirty="0">
                <a:latin typeface="Helvetica"/>
                <a:cs typeface="Helvetica"/>
              </a:rPr>
              <a:t>B</a:t>
            </a:r>
            <a:endParaRPr lang="ja-JP" altLang="en-US" dirty="0">
              <a:latin typeface="Helvetica"/>
              <a:cs typeface="Helvetica"/>
            </a:endParaRPr>
          </a:p>
        </p:txBody>
      </p:sp>
      <p:graphicFrame>
        <p:nvGraphicFramePr>
          <p:cNvPr id="65" name="グラフ 6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779134482"/>
              </p:ext>
            </p:extLst>
          </p:nvPr>
        </p:nvGraphicFramePr>
        <p:xfrm>
          <a:off x="383781" y="1258270"/>
          <a:ext cx="2889655" cy="229676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6" name="グラフ 6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12633555"/>
              </p:ext>
            </p:extLst>
          </p:nvPr>
        </p:nvGraphicFramePr>
        <p:xfrm>
          <a:off x="3593009" y="1213072"/>
          <a:ext cx="3003427" cy="23619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7" name="正方形/長方形 66"/>
          <p:cNvSpPr/>
          <p:nvPr/>
        </p:nvSpPr>
        <p:spPr>
          <a:xfrm>
            <a:off x="3875266" y="3106770"/>
            <a:ext cx="262310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82" name="正方形/長方形 81"/>
          <p:cNvSpPr/>
          <p:nvPr/>
        </p:nvSpPr>
        <p:spPr>
          <a:xfrm rot="5400000">
            <a:off x="2799035" y="2073556"/>
            <a:ext cx="1953759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83" name="直線コネクタ 82"/>
          <p:cNvCxnSpPr/>
          <p:nvPr/>
        </p:nvCxnSpPr>
        <p:spPr>
          <a:xfrm>
            <a:off x="3986134" y="1383349"/>
            <a:ext cx="0" cy="1691997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="" xmlns:a16="http://schemas.microsoft.com/office/drawing/2014/main" id="{EF05A6EE-448A-1840-A05D-D94077708515}"/>
              </a:ext>
            </a:extLst>
          </p:cNvPr>
          <p:cNvSpPr txBox="1"/>
          <p:nvPr/>
        </p:nvSpPr>
        <p:spPr>
          <a:xfrm>
            <a:off x="3676634" y="2679575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9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5" name="テキスト ボックス 84"/>
          <p:cNvSpPr txBox="1"/>
          <p:nvPr/>
        </p:nvSpPr>
        <p:spPr>
          <a:xfrm rot="16200000">
            <a:off x="2719119" y="2056481"/>
            <a:ext cx="16380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% of original weight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86" name="テキスト ボックス 85">
            <a:extLst>
              <a:ext uri="{FF2B5EF4-FFF2-40B4-BE49-F238E27FC236}">
                <a16:creationId xmlns="" xmlns:a16="http://schemas.microsoft.com/office/drawing/2014/main" id="{EF05A6EE-448A-1840-A05D-D94077708515}"/>
              </a:ext>
            </a:extLst>
          </p:cNvPr>
          <p:cNvSpPr txBox="1"/>
          <p:nvPr/>
        </p:nvSpPr>
        <p:spPr>
          <a:xfrm>
            <a:off x="3598239" y="2205391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7" name="テキスト ボックス 86">
            <a:extLst>
              <a:ext uri="{FF2B5EF4-FFF2-40B4-BE49-F238E27FC236}">
                <a16:creationId xmlns="" xmlns:a16="http://schemas.microsoft.com/office/drawing/2014/main" id="{EF05A6EE-448A-1840-A05D-D94077708515}"/>
              </a:ext>
            </a:extLst>
          </p:cNvPr>
          <p:cNvSpPr txBox="1"/>
          <p:nvPr/>
        </p:nvSpPr>
        <p:spPr>
          <a:xfrm>
            <a:off x="3609999" y="1719769"/>
            <a:ext cx="433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88" name="テキスト ボックス 87">
            <a:extLst>
              <a:ext uri="{FF2B5EF4-FFF2-40B4-BE49-F238E27FC236}">
                <a16:creationId xmlns="" xmlns:a16="http://schemas.microsoft.com/office/drawing/2014/main" id="{EF05A6EE-448A-1840-A05D-D94077708515}"/>
              </a:ext>
            </a:extLst>
          </p:cNvPr>
          <p:cNvSpPr txBox="1"/>
          <p:nvPr/>
        </p:nvSpPr>
        <p:spPr>
          <a:xfrm>
            <a:off x="3607133" y="1252684"/>
            <a:ext cx="44142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0" name="正方形/長方形 89"/>
          <p:cNvSpPr/>
          <p:nvPr/>
        </p:nvSpPr>
        <p:spPr>
          <a:xfrm>
            <a:off x="502342" y="3132205"/>
            <a:ext cx="2641838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91" name="直線コネクタ 90"/>
          <p:cNvCxnSpPr/>
          <p:nvPr/>
        </p:nvCxnSpPr>
        <p:spPr>
          <a:xfrm flipV="1">
            <a:off x="1752910" y="3082896"/>
            <a:ext cx="1357611" cy="3184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テキスト ボックス 91">
            <a:extLst>
              <a:ext uri="{FF2B5EF4-FFF2-40B4-BE49-F238E27FC236}">
                <a16:creationId xmlns="" xmlns:a16="http://schemas.microsoft.com/office/drawing/2014/main" id="{79394661-8AAD-894B-B321-DF2F09BB1A34}"/>
              </a:ext>
            </a:extLst>
          </p:cNvPr>
          <p:cNvSpPr txBox="1"/>
          <p:nvPr/>
        </p:nvSpPr>
        <p:spPr>
          <a:xfrm>
            <a:off x="779560" y="30502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3" name="テキスト ボックス 92">
            <a:extLst>
              <a:ext uri="{FF2B5EF4-FFF2-40B4-BE49-F238E27FC236}">
                <a16:creationId xmlns="" xmlns:a16="http://schemas.microsoft.com/office/drawing/2014/main" id="{64CEF990-A5BD-1841-BC92-8E9FF5558D96}"/>
              </a:ext>
            </a:extLst>
          </p:cNvPr>
          <p:cNvSpPr txBox="1"/>
          <p:nvPr/>
        </p:nvSpPr>
        <p:spPr>
          <a:xfrm>
            <a:off x="992855" y="30502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4" name="テキスト ボックス 93">
            <a:extLst>
              <a:ext uri="{FF2B5EF4-FFF2-40B4-BE49-F238E27FC236}">
                <a16:creationId xmlns="" xmlns:a16="http://schemas.microsoft.com/office/drawing/2014/main" id="{B6F9BB82-7EF2-C24B-863C-A6CC60B52B68}"/>
              </a:ext>
            </a:extLst>
          </p:cNvPr>
          <p:cNvSpPr txBox="1"/>
          <p:nvPr/>
        </p:nvSpPr>
        <p:spPr>
          <a:xfrm>
            <a:off x="1234125" y="30502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="" xmlns:a16="http://schemas.microsoft.com/office/drawing/2014/main" id="{708A8313-4EBE-A84D-8CE5-144CF9CD6118}"/>
              </a:ext>
            </a:extLst>
          </p:cNvPr>
          <p:cNvSpPr txBox="1"/>
          <p:nvPr/>
        </p:nvSpPr>
        <p:spPr>
          <a:xfrm>
            <a:off x="1453015" y="3050237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="" xmlns:a16="http://schemas.microsoft.com/office/drawing/2014/main" id="{552FD492-0E6C-2447-9746-C05FAA652532}"/>
              </a:ext>
            </a:extLst>
          </p:cNvPr>
          <p:cNvSpPr txBox="1"/>
          <p:nvPr/>
        </p:nvSpPr>
        <p:spPr>
          <a:xfrm>
            <a:off x="1621550" y="305023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="" xmlns:a16="http://schemas.microsoft.com/office/drawing/2014/main" id="{EE14A61E-8929-9048-B5CD-28FB87B52101}"/>
              </a:ext>
            </a:extLst>
          </p:cNvPr>
          <p:cNvSpPr txBox="1"/>
          <p:nvPr/>
        </p:nvSpPr>
        <p:spPr>
          <a:xfrm>
            <a:off x="1858886" y="305023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8" name="テキスト ボックス 97">
            <a:extLst>
              <a:ext uri="{FF2B5EF4-FFF2-40B4-BE49-F238E27FC236}">
                <a16:creationId xmlns="" xmlns:a16="http://schemas.microsoft.com/office/drawing/2014/main" id="{AC43DEE9-DE8D-1F42-9452-B6EC573F5AEF}"/>
              </a:ext>
            </a:extLst>
          </p:cNvPr>
          <p:cNvSpPr txBox="1"/>
          <p:nvPr/>
        </p:nvSpPr>
        <p:spPr>
          <a:xfrm>
            <a:off x="2096222" y="305023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99" name="テキスト ボックス 98">
            <a:extLst>
              <a:ext uri="{FF2B5EF4-FFF2-40B4-BE49-F238E27FC236}">
                <a16:creationId xmlns="" xmlns:a16="http://schemas.microsoft.com/office/drawing/2014/main" id="{4A6B2414-AE33-0B4D-A30D-13F9DAF35054}"/>
              </a:ext>
            </a:extLst>
          </p:cNvPr>
          <p:cNvSpPr txBox="1"/>
          <p:nvPr/>
        </p:nvSpPr>
        <p:spPr>
          <a:xfrm>
            <a:off x="2305583" y="305023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0" name="テキスト ボックス 99">
            <a:extLst>
              <a:ext uri="{FF2B5EF4-FFF2-40B4-BE49-F238E27FC236}">
                <a16:creationId xmlns="" xmlns:a16="http://schemas.microsoft.com/office/drawing/2014/main" id="{DA6CE7E4-2C9E-4C44-9865-4688AC918023}"/>
              </a:ext>
            </a:extLst>
          </p:cNvPr>
          <p:cNvSpPr txBox="1"/>
          <p:nvPr/>
        </p:nvSpPr>
        <p:spPr>
          <a:xfrm>
            <a:off x="2537324" y="305023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1" name="テキスト ボックス 100">
            <a:extLst>
              <a:ext uri="{FF2B5EF4-FFF2-40B4-BE49-F238E27FC236}">
                <a16:creationId xmlns="" xmlns:a16="http://schemas.microsoft.com/office/drawing/2014/main" id="{C0F527A3-9827-C44F-AD18-EDB55DE1211A}"/>
              </a:ext>
            </a:extLst>
          </p:cNvPr>
          <p:cNvSpPr txBox="1"/>
          <p:nvPr/>
        </p:nvSpPr>
        <p:spPr>
          <a:xfrm>
            <a:off x="2791447" y="3050237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856878" y="3242825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after immunization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03" name="テキスト ボックス 102">
            <a:extLst>
              <a:ext uri="{FF2B5EF4-FFF2-40B4-BE49-F238E27FC236}">
                <a16:creationId xmlns="" xmlns:a16="http://schemas.microsoft.com/office/drawing/2014/main" id="{79394661-8AAD-894B-B321-DF2F09BB1A34}"/>
              </a:ext>
            </a:extLst>
          </p:cNvPr>
          <p:cNvSpPr txBox="1"/>
          <p:nvPr/>
        </p:nvSpPr>
        <p:spPr>
          <a:xfrm>
            <a:off x="555075" y="3047696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cxnSp>
        <p:nvCxnSpPr>
          <p:cNvPr id="104" name="直線コネクタ 103"/>
          <p:cNvCxnSpPr/>
          <p:nvPr/>
        </p:nvCxnSpPr>
        <p:spPr>
          <a:xfrm>
            <a:off x="3983295" y="3076183"/>
            <a:ext cx="2420320" cy="0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5" name="テキスト ボックス 104">
            <a:extLst>
              <a:ext uri="{FF2B5EF4-FFF2-40B4-BE49-F238E27FC236}">
                <a16:creationId xmlns="" xmlns:a16="http://schemas.microsoft.com/office/drawing/2014/main" id="{79394661-8AAD-894B-B321-DF2F09BB1A34}"/>
              </a:ext>
            </a:extLst>
          </p:cNvPr>
          <p:cNvSpPr txBox="1"/>
          <p:nvPr/>
        </p:nvSpPr>
        <p:spPr>
          <a:xfrm>
            <a:off x="4128604" y="303955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="" xmlns:a16="http://schemas.microsoft.com/office/drawing/2014/main" id="{64CEF990-A5BD-1841-BC92-8E9FF5558D96}"/>
              </a:ext>
            </a:extLst>
          </p:cNvPr>
          <p:cNvSpPr txBox="1"/>
          <p:nvPr/>
        </p:nvSpPr>
        <p:spPr>
          <a:xfrm>
            <a:off x="4347494" y="303955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="" xmlns:a16="http://schemas.microsoft.com/office/drawing/2014/main" id="{B6F9BB82-7EF2-C24B-863C-A6CC60B52B68}"/>
              </a:ext>
            </a:extLst>
          </p:cNvPr>
          <p:cNvSpPr txBox="1"/>
          <p:nvPr/>
        </p:nvSpPr>
        <p:spPr>
          <a:xfrm>
            <a:off x="4560789" y="303955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8" name="テキスト ボックス 107">
            <a:extLst>
              <a:ext uri="{FF2B5EF4-FFF2-40B4-BE49-F238E27FC236}">
                <a16:creationId xmlns="" xmlns:a16="http://schemas.microsoft.com/office/drawing/2014/main" id="{708A8313-4EBE-A84D-8CE5-144CF9CD6118}"/>
              </a:ext>
            </a:extLst>
          </p:cNvPr>
          <p:cNvSpPr txBox="1"/>
          <p:nvPr/>
        </p:nvSpPr>
        <p:spPr>
          <a:xfrm>
            <a:off x="4785274" y="303955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09" name="テキスト ボックス 108">
            <a:extLst>
              <a:ext uri="{FF2B5EF4-FFF2-40B4-BE49-F238E27FC236}">
                <a16:creationId xmlns="" xmlns:a16="http://schemas.microsoft.com/office/drawing/2014/main" id="{552FD492-0E6C-2447-9746-C05FAA652532}"/>
              </a:ext>
            </a:extLst>
          </p:cNvPr>
          <p:cNvSpPr txBox="1"/>
          <p:nvPr/>
        </p:nvSpPr>
        <p:spPr>
          <a:xfrm>
            <a:off x="4942619" y="303955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0" name="テキスト ボックス 109">
            <a:extLst>
              <a:ext uri="{FF2B5EF4-FFF2-40B4-BE49-F238E27FC236}">
                <a16:creationId xmlns="" xmlns:a16="http://schemas.microsoft.com/office/drawing/2014/main" id="{EE14A61E-8929-9048-B5CD-28FB87B52101}"/>
              </a:ext>
            </a:extLst>
          </p:cNvPr>
          <p:cNvSpPr txBox="1"/>
          <p:nvPr/>
        </p:nvSpPr>
        <p:spPr>
          <a:xfrm>
            <a:off x="5151980" y="303955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1" name="テキスト ボックス 110">
            <a:extLst>
              <a:ext uri="{FF2B5EF4-FFF2-40B4-BE49-F238E27FC236}">
                <a16:creationId xmlns="" xmlns:a16="http://schemas.microsoft.com/office/drawing/2014/main" id="{AC43DEE9-DE8D-1F42-9452-B6EC573F5AEF}"/>
              </a:ext>
            </a:extLst>
          </p:cNvPr>
          <p:cNvSpPr txBox="1"/>
          <p:nvPr/>
        </p:nvSpPr>
        <p:spPr>
          <a:xfrm>
            <a:off x="5389316" y="303955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2" name="テキスト ボックス 111">
            <a:extLst>
              <a:ext uri="{FF2B5EF4-FFF2-40B4-BE49-F238E27FC236}">
                <a16:creationId xmlns="" xmlns:a16="http://schemas.microsoft.com/office/drawing/2014/main" id="{4A6B2414-AE33-0B4D-A30D-13F9DAF35054}"/>
              </a:ext>
            </a:extLst>
          </p:cNvPr>
          <p:cNvSpPr txBox="1"/>
          <p:nvPr/>
        </p:nvSpPr>
        <p:spPr>
          <a:xfrm>
            <a:off x="5598677" y="303955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6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3" name="テキスト ボックス 112">
            <a:extLst>
              <a:ext uri="{FF2B5EF4-FFF2-40B4-BE49-F238E27FC236}">
                <a16:creationId xmlns="" xmlns:a16="http://schemas.microsoft.com/office/drawing/2014/main" id="{DA6CE7E4-2C9E-4C44-9865-4688AC918023}"/>
              </a:ext>
            </a:extLst>
          </p:cNvPr>
          <p:cNvSpPr txBox="1"/>
          <p:nvPr/>
        </p:nvSpPr>
        <p:spPr>
          <a:xfrm>
            <a:off x="5830418" y="303955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8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="" xmlns:a16="http://schemas.microsoft.com/office/drawing/2014/main" id="{C0F527A3-9827-C44F-AD18-EDB55DE1211A}"/>
              </a:ext>
            </a:extLst>
          </p:cNvPr>
          <p:cNvSpPr txBox="1"/>
          <p:nvPr/>
        </p:nvSpPr>
        <p:spPr>
          <a:xfrm>
            <a:off x="6084541" y="3039559"/>
            <a:ext cx="3558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15" name="テキスト ボックス 114"/>
          <p:cNvSpPr txBox="1"/>
          <p:nvPr/>
        </p:nvSpPr>
        <p:spPr>
          <a:xfrm>
            <a:off x="4149972" y="3232147"/>
            <a:ext cx="196332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Days after immunization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16" name="テキスト ボックス 115">
            <a:extLst>
              <a:ext uri="{FF2B5EF4-FFF2-40B4-BE49-F238E27FC236}">
                <a16:creationId xmlns="" xmlns:a16="http://schemas.microsoft.com/office/drawing/2014/main" id="{79394661-8AAD-894B-B321-DF2F09BB1A34}"/>
              </a:ext>
            </a:extLst>
          </p:cNvPr>
          <p:cNvSpPr txBox="1"/>
          <p:nvPr/>
        </p:nvSpPr>
        <p:spPr>
          <a:xfrm>
            <a:off x="3915309" y="3037018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29" name="正方形/長方形 128"/>
          <p:cNvSpPr/>
          <p:nvPr/>
        </p:nvSpPr>
        <p:spPr>
          <a:xfrm rot="16200000">
            <a:off x="-625200" y="1951010"/>
            <a:ext cx="2031002" cy="36794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ea typeface="Helvetica" charset="0"/>
              <a:cs typeface="Helvetica"/>
            </a:endParaRPr>
          </a:p>
        </p:txBody>
      </p:sp>
      <p:cxnSp>
        <p:nvCxnSpPr>
          <p:cNvPr id="130" name="直線コネクタ 129"/>
          <p:cNvCxnSpPr/>
          <p:nvPr/>
        </p:nvCxnSpPr>
        <p:spPr>
          <a:xfrm flipH="1">
            <a:off x="623971" y="1404419"/>
            <a:ext cx="0" cy="1689089"/>
          </a:xfrm>
          <a:prstGeom prst="line">
            <a:avLst/>
          </a:prstGeom>
          <a:ln w="12700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1" name="テキスト ボックス 130">
            <a:extLst>
              <a:ext uri="{FF2B5EF4-FFF2-40B4-BE49-F238E27FC236}">
                <a16:creationId xmlns="" xmlns:a16="http://schemas.microsoft.com/office/drawing/2014/main" id="{F07E629E-B719-D946-9289-C4F6303E9A11}"/>
              </a:ext>
            </a:extLst>
          </p:cNvPr>
          <p:cNvSpPr txBox="1"/>
          <p:nvPr/>
        </p:nvSpPr>
        <p:spPr>
          <a:xfrm>
            <a:off x="387390" y="2917711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0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="" xmlns:a16="http://schemas.microsoft.com/office/drawing/2014/main" id="{EF05A6EE-448A-1840-A05D-D94077708515}"/>
              </a:ext>
            </a:extLst>
          </p:cNvPr>
          <p:cNvSpPr txBox="1"/>
          <p:nvPr/>
        </p:nvSpPr>
        <p:spPr>
          <a:xfrm>
            <a:off x="373183" y="260672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1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3" name="テキスト ボックス 132">
            <a:extLst>
              <a:ext uri="{FF2B5EF4-FFF2-40B4-BE49-F238E27FC236}">
                <a16:creationId xmlns="" xmlns:a16="http://schemas.microsoft.com/office/drawing/2014/main" id="{AC0C3899-0921-4F4C-93E7-1B96239CE567}"/>
              </a:ext>
            </a:extLst>
          </p:cNvPr>
          <p:cNvSpPr txBox="1"/>
          <p:nvPr/>
        </p:nvSpPr>
        <p:spPr>
          <a:xfrm>
            <a:off x="373183" y="226218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2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4" name="テキスト ボックス 133">
            <a:extLst>
              <a:ext uri="{FF2B5EF4-FFF2-40B4-BE49-F238E27FC236}">
                <a16:creationId xmlns="" xmlns:a16="http://schemas.microsoft.com/office/drawing/2014/main" id="{0E4B548D-540A-954F-AAC0-F6D6CA09E4FA}"/>
              </a:ext>
            </a:extLst>
          </p:cNvPr>
          <p:cNvSpPr txBox="1"/>
          <p:nvPr/>
        </p:nvSpPr>
        <p:spPr>
          <a:xfrm>
            <a:off x="373183" y="1925699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3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="" xmlns:a16="http://schemas.microsoft.com/office/drawing/2014/main" id="{F4C64E0E-D4C1-7F4F-9D02-BDC788DDE822}"/>
              </a:ext>
            </a:extLst>
          </p:cNvPr>
          <p:cNvSpPr txBox="1"/>
          <p:nvPr/>
        </p:nvSpPr>
        <p:spPr>
          <a:xfrm>
            <a:off x="373183" y="127107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5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6" name="テキスト ボックス 135"/>
          <p:cNvSpPr txBox="1"/>
          <p:nvPr/>
        </p:nvSpPr>
        <p:spPr>
          <a:xfrm rot="16200000">
            <a:off x="-330467" y="2127457"/>
            <a:ext cx="120244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 charset="0"/>
                <a:ea typeface="Helvetica" charset="0"/>
                <a:cs typeface="Helvetica" charset="0"/>
              </a:rPr>
              <a:t>Clinical Score</a:t>
            </a:r>
            <a:endParaRPr lang="ja-JP" altLang="en-US" sz="1200" b="1" dirty="0">
              <a:latin typeface="Helvetica" charset="0"/>
              <a:ea typeface="Helvetica" charset="0"/>
              <a:cs typeface="Helvetica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="" xmlns:a16="http://schemas.microsoft.com/office/drawing/2014/main" id="{0E4B548D-540A-954F-AAC0-F6D6CA09E4FA}"/>
              </a:ext>
            </a:extLst>
          </p:cNvPr>
          <p:cNvSpPr txBox="1"/>
          <p:nvPr/>
        </p:nvSpPr>
        <p:spPr>
          <a:xfrm>
            <a:off x="367823" y="1603554"/>
            <a:ext cx="2702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cs typeface="Helvetica"/>
              </a:rPr>
              <a:t>4</a:t>
            </a:r>
            <a:endParaRPr lang="ja-JP" altLang="en-US" sz="1200" b="1" dirty="0">
              <a:latin typeface="Helvetica"/>
              <a:cs typeface="Helvetica"/>
            </a:endParaRPr>
          </a:p>
        </p:txBody>
      </p:sp>
      <p:sp>
        <p:nvSpPr>
          <p:cNvPr id="139" name="二等辺三角形 138"/>
          <p:cNvSpPr/>
          <p:nvPr/>
        </p:nvSpPr>
        <p:spPr>
          <a:xfrm>
            <a:off x="842942" y="1900901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140" name="円/楕円 139"/>
          <p:cNvSpPr/>
          <p:nvPr/>
        </p:nvSpPr>
        <p:spPr>
          <a:xfrm>
            <a:off x="835503" y="2167879"/>
            <a:ext cx="64355" cy="64349"/>
          </a:xfrm>
          <a:prstGeom prst="ellipse">
            <a:avLst/>
          </a:prstGeom>
          <a:solidFill>
            <a:srgbClr val="0000FF"/>
          </a:solidFill>
          <a:ln w="285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141" name="テキスト ボックス 140">
            <a:extLst>
              <a:ext uri="{FF2B5EF4-FFF2-40B4-BE49-F238E27FC236}">
                <a16:creationId xmlns="" xmlns:a16="http://schemas.microsoft.com/office/drawing/2014/main" id="{2A3321E8-A6B8-CC46-829B-47981A12AF76}"/>
              </a:ext>
            </a:extLst>
          </p:cNvPr>
          <p:cNvSpPr txBox="1"/>
          <p:nvPr/>
        </p:nvSpPr>
        <p:spPr>
          <a:xfrm>
            <a:off x="961403" y="1775623"/>
            <a:ext cx="5052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AE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142" name="テキスト ボックス 141">
            <a:extLst>
              <a:ext uri="{FF2B5EF4-FFF2-40B4-BE49-F238E27FC236}">
                <a16:creationId xmlns="" xmlns:a16="http://schemas.microsoft.com/office/drawing/2014/main" id="{2A3321E8-A6B8-CC46-829B-47981A12AF76}"/>
              </a:ext>
            </a:extLst>
          </p:cNvPr>
          <p:cNvSpPr txBox="1"/>
          <p:nvPr/>
        </p:nvSpPr>
        <p:spPr>
          <a:xfrm>
            <a:off x="962450" y="2041745"/>
            <a:ext cx="74892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poly I:C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  <p:sp>
        <p:nvSpPr>
          <p:cNvPr id="143" name="二等辺三角形 142"/>
          <p:cNvSpPr/>
          <p:nvPr/>
        </p:nvSpPr>
        <p:spPr>
          <a:xfrm>
            <a:off x="4197080" y="2610392"/>
            <a:ext cx="60558" cy="45719"/>
          </a:xfrm>
          <a:prstGeom prst="triangle">
            <a:avLst/>
          </a:prstGeom>
          <a:solidFill>
            <a:schemeClr val="tx1"/>
          </a:solidFill>
          <a:ln w="28575"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800" b="1">
              <a:latin typeface="Helvetica"/>
              <a:cs typeface="Helvetica"/>
            </a:endParaRPr>
          </a:p>
        </p:txBody>
      </p:sp>
      <p:sp>
        <p:nvSpPr>
          <p:cNvPr id="144" name="円/楕円 143"/>
          <p:cNvSpPr/>
          <p:nvPr/>
        </p:nvSpPr>
        <p:spPr>
          <a:xfrm>
            <a:off x="4189641" y="2877370"/>
            <a:ext cx="64355" cy="64349"/>
          </a:xfrm>
          <a:prstGeom prst="ellipse">
            <a:avLst/>
          </a:prstGeom>
          <a:solidFill>
            <a:srgbClr val="0000FF"/>
          </a:solidFill>
          <a:ln w="28575">
            <a:solidFill>
              <a:srgbClr val="0000FF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sz="1200" b="1">
              <a:latin typeface="Helvetica"/>
              <a:cs typeface="Helvetica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="" xmlns:a16="http://schemas.microsoft.com/office/drawing/2014/main" id="{2A3321E8-A6B8-CC46-829B-47981A12AF76}"/>
              </a:ext>
            </a:extLst>
          </p:cNvPr>
          <p:cNvSpPr txBox="1"/>
          <p:nvPr/>
        </p:nvSpPr>
        <p:spPr>
          <a:xfrm>
            <a:off x="4315541" y="2485114"/>
            <a:ext cx="5052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EAE</a:t>
            </a:r>
            <a:r>
              <a:rPr lang="ja-JP" altLang="en-US" sz="1200" b="1" dirty="0">
                <a:latin typeface="Helvetica"/>
                <a:ea typeface="Helvetica" charset="0"/>
                <a:cs typeface="Helvetica"/>
              </a:rPr>
              <a:t> </a:t>
            </a:r>
          </a:p>
        </p:txBody>
      </p:sp>
      <p:sp>
        <p:nvSpPr>
          <p:cNvPr id="146" name="テキスト ボックス 145">
            <a:extLst>
              <a:ext uri="{FF2B5EF4-FFF2-40B4-BE49-F238E27FC236}">
                <a16:creationId xmlns="" xmlns:a16="http://schemas.microsoft.com/office/drawing/2014/main" id="{2A3321E8-A6B8-CC46-829B-47981A12AF76}"/>
              </a:ext>
            </a:extLst>
          </p:cNvPr>
          <p:cNvSpPr txBox="1"/>
          <p:nvPr/>
        </p:nvSpPr>
        <p:spPr>
          <a:xfrm>
            <a:off x="4316588" y="2745641"/>
            <a:ext cx="74892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b="1" dirty="0">
                <a:latin typeface="Helvetica"/>
                <a:ea typeface="Helvetica" charset="0"/>
                <a:cs typeface="Helvetica"/>
              </a:rPr>
              <a:t>poly I:C</a:t>
            </a:r>
            <a:endParaRPr lang="ja-JP" altLang="en-US" sz="1200" b="1" dirty="0">
              <a:latin typeface="Helvetica"/>
              <a:ea typeface="Helvetica" charset="0"/>
              <a:cs typeface="Helvetica"/>
            </a:endParaRPr>
          </a:p>
        </p:txBody>
      </p:sp>
    </p:spTree>
    <p:extLst>
      <p:ext uri="{BB962C8B-B14F-4D97-AF65-F5344CB8AC3E}">
        <p14:creationId xmlns:p14="http://schemas.microsoft.com/office/powerpoint/2010/main" val="269471456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28575">
          <a:solidFill>
            <a:schemeClr val="tx1"/>
          </a:solidFill>
        </a:ln>
        <a:effectLst/>
      </a:spPr>
      <a:bodyPr rtlCol="0" anchor="ctr"/>
      <a:lstStyle>
        <a:defPPr algn="ctr">
          <a:defRPr sz="1200" b="1">
            <a:latin typeface="Helvetica"/>
            <a:cs typeface="Helvetica"/>
          </a:defRPr>
        </a:defPPr>
      </a:lstStyle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196</TotalTime>
  <Words>58</Words>
  <Application>Microsoft Macintosh PowerPoint</Application>
  <PresentationFormat>画面に合わせる (4:3)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ＭＳ Ｐゴシック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5.0032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IDC</dc:creator>
  <cp:keywords/>
  <dc:description/>
  <cp:lastModifiedBy>神山長慶</cp:lastModifiedBy>
  <cp:revision>331</cp:revision>
  <cp:lastPrinted>2024-05-22T05:30:17Z</cp:lastPrinted>
  <dcterms:created xsi:type="dcterms:W3CDTF">2022-03-10T04:52:23Z</dcterms:created>
  <dcterms:modified xsi:type="dcterms:W3CDTF">2025-11-04T10:45:21Z</dcterms:modified>
  <cp:category/>
</cp:coreProperties>
</file>